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40538" cy="8640763"/>
  <p:notesSz cx="6858000" cy="9144000"/>
  <p:defaultTextStyle>
    <a:defPPr>
      <a:defRPr lang="en-US"/>
    </a:defPPr>
    <a:lvl1pPr marL="0" algn="l" defTabSz="884591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42295" algn="l" defTabSz="884591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84591" algn="l" defTabSz="884591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326886" algn="l" defTabSz="884591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769181" algn="l" defTabSz="884591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211476" algn="l" defTabSz="884591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653772" algn="l" defTabSz="884591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3096067" algn="l" defTabSz="884591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538362" algn="l" defTabSz="884591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60" d="100"/>
          <a:sy n="160" d="100"/>
        </p:scale>
        <p:origin x="-448" y="-80"/>
      </p:cViewPr>
      <p:guideLst>
        <p:guide orient="horz" pos="2722"/>
        <p:guide pos="21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2684239"/>
            <a:ext cx="5814457" cy="18521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6081" y="4896432"/>
            <a:ext cx="4788377" cy="22081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422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845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26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7691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114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6537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0960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5383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4657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998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19542" y="462042"/>
            <a:ext cx="1154341" cy="982886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6521" y="462042"/>
            <a:ext cx="3349014" cy="982886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2170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8626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56" y="5552490"/>
            <a:ext cx="5814457" cy="1716152"/>
          </a:xfrm>
        </p:spPr>
        <p:txBody>
          <a:bodyPr anchor="t"/>
          <a:lstStyle>
            <a:lvl1pPr algn="l">
              <a:defRPr sz="39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56" y="3662325"/>
            <a:ext cx="5814457" cy="1890166"/>
          </a:xfrm>
        </p:spPr>
        <p:txBody>
          <a:bodyPr anchor="b"/>
          <a:lstStyle>
            <a:lvl1pPr marL="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1pPr>
            <a:lvl2pPr marL="44229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845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3268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76918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1147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65377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09606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5383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018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6521" y="2688238"/>
            <a:ext cx="2251677" cy="760267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2207" y="2688238"/>
            <a:ext cx="2251677" cy="760267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9641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027" y="346031"/>
            <a:ext cx="6156484" cy="1440127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027" y="1934171"/>
            <a:ext cx="3022426" cy="806071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42295" indent="0">
              <a:buNone/>
              <a:defRPr sz="1900" b="1"/>
            </a:lvl2pPr>
            <a:lvl3pPr marL="884591" indent="0">
              <a:buNone/>
              <a:defRPr sz="1700" b="1"/>
            </a:lvl3pPr>
            <a:lvl4pPr marL="1326886" indent="0">
              <a:buNone/>
              <a:defRPr sz="1500" b="1"/>
            </a:lvl4pPr>
            <a:lvl5pPr marL="1769181" indent="0">
              <a:buNone/>
              <a:defRPr sz="1500" b="1"/>
            </a:lvl5pPr>
            <a:lvl6pPr marL="2211476" indent="0">
              <a:buNone/>
              <a:defRPr sz="1500" b="1"/>
            </a:lvl6pPr>
            <a:lvl7pPr marL="2653772" indent="0">
              <a:buNone/>
              <a:defRPr sz="1500" b="1"/>
            </a:lvl7pPr>
            <a:lvl8pPr marL="3096067" indent="0">
              <a:buNone/>
              <a:defRPr sz="1500" b="1"/>
            </a:lvl8pPr>
            <a:lvl9pPr marL="3538362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027" y="2740242"/>
            <a:ext cx="3022426" cy="4978440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4899" y="1934171"/>
            <a:ext cx="3023613" cy="806071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42295" indent="0">
              <a:buNone/>
              <a:defRPr sz="1900" b="1"/>
            </a:lvl2pPr>
            <a:lvl3pPr marL="884591" indent="0">
              <a:buNone/>
              <a:defRPr sz="1700" b="1"/>
            </a:lvl3pPr>
            <a:lvl4pPr marL="1326886" indent="0">
              <a:buNone/>
              <a:defRPr sz="1500" b="1"/>
            </a:lvl4pPr>
            <a:lvl5pPr marL="1769181" indent="0">
              <a:buNone/>
              <a:defRPr sz="1500" b="1"/>
            </a:lvl5pPr>
            <a:lvl6pPr marL="2211476" indent="0">
              <a:buNone/>
              <a:defRPr sz="1500" b="1"/>
            </a:lvl6pPr>
            <a:lvl7pPr marL="2653772" indent="0">
              <a:buNone/>
              <a:defRPr sz="1500" b="1"/>
            </a:lvl7pPr>
            <a:lvl8pPr marL="3096067" indent="0">
              <a:buNone/>
              <a:defRPr sz="1500" b="1"/>
            </a:lvl8pPr>
            <a:lvl9pPr marL="3538362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4899" y="2740242"/>
            <a:ext cx="3023613" cy="4978440"/>
          </a:xfrm>
        </p:spPr>
        <p:txBody>
          <a:bodyPr/>
          <a:lstStyle>
            <a:lvl1pPr>
              <a:defRPr sz="2300"/>
            </a:lvl1pPr>
            <a:lvl2pPr>
              <a:defRPr sz="19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547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2298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30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027" y="344031"/>
            <a:ext cx="2250490" cy="1464129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4460" y="344031"/>
            <a:ext cx="3824051" cy="7374652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3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027" y="1808160"/>
            <a:ext cx="2250490" cy="5910523"/>
          </a:xfrm>
        </p:spPr>
        <p:txBody>
          <a:bodyPr/>
          <a:lstStyle>
            <a:lvl1pPr marL="0" indent="0">
              <a:buNone/>
              <a:defRPr sz="1400"/>
            </a:lvl1pPr>
            <a:lvl2pPr marL="442295" indent="0">
              <a:buNone/>
              <a:defRPr sz="1200"/>
            </a:lvl2pPr>
            <a:lvl3pPr marL="884591" indent="0">
              <a:buNone/>
              <a:defRPr sz="1000"/>
            </a:lvl3pPr>
            <a:lvl4pPr marL="1326886" indent="0">
              <a:buNone/>
              <a:defRPr sz="900"/>
            </a:lvl4pPr>
            <a:lvl5pPr marL="1769181" indent="0">
              <a:buNone/>
              <a:defRPr sz="900"/>
            </a:lvl5pPr>
            <a:lvl6pPr marL="2211476" indent="0">
              <a:buNone/>
              <a:defRPr sz="900"/>
            </a:lvl6pPr>
            <a:lvl7pPr marL="2653772" indent="0">
              <a:buNone/>
              <a:defRPr sz="900"/>
            </a:lvl7pPr>
            <a:lvl8pPr marL="3096067" indent="0">
              <a:buNone/>
              <a:defRPr sz="900"/>
            </a:lvl8pPr>
            <a:lvl9pPr marL="3538362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6534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0793" y="6048535"/>
            <a:ext cx="4104323" cy="714064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0793" y="772068"/>
            <a:ext cx="4104323" cy="5184458"/>
          </a:xfrm>
        </p:spPr>
        <p:txBody>
          <a:bodyPr/>
          <a:lstStyle>
            <a:lvl1pPr marL="0" indent="0">
              <a:buNone/>
              <a:defRPr sz="3100"/>
            </a:lvl1pPr>
            <a:lvl2pPr marL="442295" indent="0">
              <a:buNone/>
              <a:defRPr sz="2700"/>
            </a:lvl2pPr>
            <a:lvl3pPr marL="884591" indent="0">
              <a:buNone/>
              <a:defRPr sz="2300"/>
            </a:lvl3pPr>
            <a:lvl4pPr marL="1326886" indent="0">
              <a:buNone/>
              <a:defRPr sz="1900"/>
            </a:lvl4pPr>
            <a:lvl5pPr marL="1769181" indent="0">
              <a:buNone/>
              <a:defRPr sz="1900"/>
            </a:lvl5pPr>
            <a:lvl6pPr marL="2211476" indent="0">
              <a:buNone/>
              <a:defRPr sz="1900"/>
            </a:lvl6pPr>
            <a:lvl7pPr marL="2653772" indent="0">
              <a:buNone/>
              <a:defRPr sz="1900"/>
            </a:lvl7pPr>
            <a:lvl8pPr marL="3096067" indent="0">
              <a:buNone/>
              <a:defRPr sz="1900"/>
            </a:lvl8pPr>
            <a:lvl9pPr marL="3538362" indent="0">
              <a:buNone/>
              <a:defRPr sz="19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0793" y="6762598"/>
            <a:ext cx="4104323" cy="1014089"/>
          </a:xfrm>
        </p:spPr>
        <p:txBody>
          <a:bodyPr/>
          <a:lstStyle>
            <a:lvl1pPr marL="0" indent="0">
              <a:buNone/>
              <a:defRPr sz="1400"/>
            </a:lvl1pPr>
            <a:lvl2pPr marL="442295" indent="0">
              <a:buNone/>
              <a:defRPr sz="1200"/>
            </a:lvl2pPr>
            <a:lvl3pPr marL="884591" indent="0">
              <a:buNone/>
              <a:defRPr sz="1000"/>
            </a:lvl3pPr>
            <a:lvl4pPr marL="1326886" indent="0">
              <a:buNone/>
              <a:defRPr sz="900"/>
            </a:lvl4pPr>
            <a:lvl5pPr marL="1769181" indent="0">
              <a:buNone/>
              <a:defRPr sz="900"/>
            </a:lvl5pPr>
            <a:lvl6pPr marL="2211476" indent="0">
              <a:buNone/>
              <a:defRPr sz="900"/>
            </a:lvl6pPr>
            <a:lvl7pPr marL="2653772" indent="0">
              <a:buNone/>
              <a:defRPr sz="900"/>
            </a:lvl7pPr>
            <a:lvl8pPr marL="3096067" indent="0">
              <a:buNone/>
              <a:defRPr sz="900"/>
            </a:lvl8pPr>
            <a:lvl9pPr marL="3538362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6783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027" y="346031"/>
            <a:ext cx="6156484" cy="1440127"/>
          </a:xfrm>
          <a:prstGeom prst="rect">
            <a:avLst/>
          </a:prstGeom>
        </p:spPr>
        <p:txBody>
          <a:bodyPr vert="horz" lIns="88459" tIns="44230" rIns="88459" bIns="4423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027" y="2016179"/>
            <a:ext cx="6156484" cy="5702504"/>
          </a:xfrm>
          <a:prstGeom prst="rect">
            <a:avLst/>
          </a:prstGeom>
        </p:spPr>
        <p:txBody>
          <a:bodyPr vert="horz" lIns="88459" tIns="44230" rIns="88459" bIns="4423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027" y="8008708"/>
            <a:ext cx="1596126" cy="460040"/>
          </a:xfrm>
          <a:prstGeom prst="rect">
            <a:avLst/>
          </a:prstGeom>
        </p:spPr>
        <p:txBody>
          <a:bodyPr vert="horz" lIns="88459" tIns="44230" rIns="88459" bIns="4423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B70E79-B0C7-4FE7-89BD-442CBE976DBC}" type="datetimeFigureOut">
              <a:rPr lang="en-GB" smtClean="0"/>
              <a:t>03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37184" y="8008708"/>
            <a:ext cx="2166170" cy="460040"/>
          </a:xfrm>
          <a:prstGeom prst="rect">
            <a:avLst/>
          </a:prstGeom>
        </p:spPr>
        <p:txBody>
          <a:bodyPr vert="horz" lIns="88459" tIns="44230" rIns="88459" bIns="4423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02385" y="8008708"/>
            <a:ext cx="1596126" cy="460040"/>
          </a:xfrm>
          <a:prstGeom prst="rect">
            <a:avLst/>
          </a:prstGeom>
        </p:spPr>
        <p:txBody>
          <a:bodyPr vert="horz" lIns="88459" tIns="44230" rIns="88459" bIns="4423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896D0-D2D2-474E-A2B4-1E0BD5D027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42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84591" rtl="0" eaLnBrk="1" latinLnBrk="0" hangingPunct="1">
        <a:spcBef>
          <a:spcPct val="0"/>
        </a:spcBef>
        <a:buNone/>
        <a:defRPr sz="4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1721" indent="-331721" algn="l" defTabSz="884591" rtl="0" eaLnBrk="1" latinLnBrk="0" hangingPunct="1">
        <a:spcBef>
          <a:spcPct val="20000"/>
        </a:spcBef>
        <a:buFont typeface="Arial" pitchFamily="34" charset="0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1pPr>
      <a:lvl2pPr marL="718730" indent="-276435" algn="l" defTabSz="884591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105738" indent="-221148" algn="l" defTabSz="884591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548033" indent="-221148" algn="l" defTabSz="884591" rtl="0" eaLnBrk="1" latinLnBrk="0" hangingPunct="1">
        <a:spcBef>
          <a:spcPct val="20000"/>
        </a:spcBef>
        <a:buFont typeface="Arial" pitchFamily="34" charset="0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90329" indent="-221148" algn="l" defTabSz="884591" rtl="0" eaLnBrk="1" latinLnBrk="0" hangingPunct="1">
        <a:spcBef>
          <a:spcPct val="20000"/>
        </a:spcBef>
        <a:buFont typeface="Arial" pitchFamily="34" charset="0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32624" indent="-221148" algn="l" defTabSz="884591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4919" indent="-221148" algn="l" defTabSz="884591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17215" indent="-221148" algn="l" defTabSz="884591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759510" indent="-221148" algn="l" defTabSz="884591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84591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42295" algn="l" defTabSz="884591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84591" algn="l" defTabSz="884591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26886" algn="l" defTabSz="884591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69181" algn="l" defTabSz="884591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211476" algn="l" defTabSz="884591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653772" algn="l" defTabSz="884591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096067" algn="l" defTabSz="884591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538362" algn="l" defTabSz="884591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917" y="71909"/>
            <a:ext cx="6552728" cy="8374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pSsp1	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SIDT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FH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HE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S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D---------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F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N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D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HGTH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GIGVAPG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IA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astaci_AAK39096		  1 ----------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H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E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D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-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W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HGT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T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---H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IGV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IA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laibachii_1_CCA16972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VGS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N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VNGLK-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IGVAP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IA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laibachii_2_CCA21883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VVGS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HE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S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T---------H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M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GIGV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.giganteum_ABY90127	  1 ---------------------------------------------------------------------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1_XP002897506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S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HE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S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S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F-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---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AP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2_XP002909265	  1</a:t>
            </a:r>
            <a:r>
              <a:rPr lang="en-GB" sz="650" dirty="0" smtClean="0">
                <a:solidFill>
                  <a:srgbClr val="FFFFFF"/>
                </a:solidFill>
                <a:effectLst/>
                <a:latin typeface="Courier New" pitchFamily="49" charset="0"/>
                <a:ea typeface="Calibri"/>
                <a:cs typeface="Courier New" pitchFamily="49" charset="0"/>
              </a:rPr>
              <a:t>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A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HE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3_XP002901381	  1</a:t>
            </a:r>
            <a:r>
              <a:rPr lang="en-GB" sz="650" dirty="0" smtClean="0">
                <a:solidFill>
                  <a:srgbClr val="FFFFFF"/>
                </a:solidFill>
                <a:effectLst/>
                <a:latin typeface="Courier New" pitchFamily="49" charset="0"/>
                <a:ea typeface="Calibri"/>
                <a:cs typeface="Courier New" pitchFamily="49" charset="0"/>
              </a:rPr>
              <a:t>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V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HE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TM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---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4_XP002901382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VGS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HE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---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1_EGZ19243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S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HE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T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M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---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AP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IA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2_EGZ08708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VV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HE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TM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I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3_EGZ12954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VV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HE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TM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I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4_EGZ15546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DTGVR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HE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----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G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M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---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IGVAPG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IAC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aurantiaca_YP003835151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I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F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N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NGDGTFDH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AGEC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TMG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DG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GV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I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lupini_ZP21031234	  1</a:t>
            </a:r>
            <a:r>
              <a:rPr lang="en-GB" sz="650" dirty="0" smtClean="0">
                <a:solidFill>
                  <a:srgbClr val="FFFFFF"/>
                </a:solidFill>
                <a:effectLst/>
                <a:latin typeface="Courier New" pitchFamily="49" charset="0"/>
                <a:ea typeface="Calibri"/>
                <a:cs typeface="Courier New" pitchFamily="49" charset="0"/>
              </a:rPr>
              <a:t>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I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Y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N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NGDGTFDH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AAGTC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TMG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AG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GV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I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sp_ZP04604370		  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I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F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H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K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NGDGTFDH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AGDC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HGTHTMG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DG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GV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I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onsensus		  1 . ............ .....  ....          ......  ...  ...  ............    ..........*...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 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pSsp1		 73 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INGS-GSAD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LACAQFMLC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AP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NNSW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ST--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HPAA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IIPVF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astaci_AAK39096		 6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WN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-NIRR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AQFMLC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H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CSKAP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N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YSKE-NF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ED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AG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V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laibachii_1_CCA16972	 7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P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LACAQF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P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SN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F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SKAPH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NSW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LS-S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E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laibachii_2_CCA21883	 7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LA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FMLCP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W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G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CSK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NNSW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IIPV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.giganteum_ABY90127	  7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DDG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EE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LACAQF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C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CSK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H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NNSW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-RS-D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II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1_XP002897506	 7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AQG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LA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FMLCP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P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S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CSK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VNNSW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AGIIP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A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2_XP002909265	 72 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LACAQF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C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H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SK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NNSW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AA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IPVF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FN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3_XP002901381	 72</a:t>
            </a:r>
            <a:r>
              <a:rPr lang="en-GB" sz="650" dirty="0" smtClean="0">
                <a:solidFill>
                  <a:srgbClr val="FFFFFF"/>
                </a:solidFill>
                <a:effectLst/>
                <a:latin typeface="Courier New" pitchFamily="49" charset="0"/>
                <a:ea typeface="Calibri"/>
                <a:cs typeface="Courier New" pitchFamily="49" charset="0"/>
              </a:rPr>
              <a:t>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AQFMLC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NP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APHI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SW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I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N-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4_XP002901382	 7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AQ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MLC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NP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APHI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SW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H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IPVF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K-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1_EGZ19243	 7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AQG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LA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FMLCP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P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S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CSKA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VNNSW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AGIIP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A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2_EGZ08708	 7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CAQFMLC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NA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APHI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SW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P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V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N-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3_EGZ12954	 7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CAQFMLC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NA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APHI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SW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P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V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N-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4_EGZ15546	 72 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SAS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LACAQF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C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K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CSKAP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NNSW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I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TATLT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AGIIPVF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SK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aurantiaca_YP003835151	 85 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----A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M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K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NSW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TAPSNE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E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lupini_ZP21031234	 85 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P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----A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M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K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NSW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RDPSNE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E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F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sp_ZP04604370		 85 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P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----A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M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NSW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RLPSND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E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W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G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C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onsensus		 85 ...  .  .  . .....*....*..  ... ...*.*....**.*. ..   ...  .. .* ...*..... **.*.   * 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 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pSsp1		15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LD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GSW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PN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S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YTG--ADGKPR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F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IKATN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KM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TSM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astaci_AAK39096		142 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NS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R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IV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TSMA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laibachii_1_CCA16972	150 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V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G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K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I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LLTGSNSEDGYS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PF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TSMA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laibachii_2_CCA21883	151 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T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T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CFK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V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TSM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T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.giganteum_ABY90127	 86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Y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K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R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HE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TSMA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1_XP002897506	15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D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FS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C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F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MA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2_XP002909265	151 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D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P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A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W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I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TSM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3_XP002901381	154 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D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FS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----------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WNGNSA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TSMA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4_XP002901382	151 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D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FS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----------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R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WKV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1_EGZ19243	15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D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FS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CW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F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M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2_EGZ08708	15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D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AF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FS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R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W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TSMA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3_EGZ12954	152 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D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AF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FS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L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W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TSMA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4_EGZ15546	155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V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PE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VD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WWT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I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T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aurantiaca_YP003835151	16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NY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FS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G----------Q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VP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S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TSMA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lupini_ZP21031234	162</a:t>
            </a:r>
            <a:r>
              <a:rPr lang="en-GB" sz="650" dirty="0" smtClean="0">
                <a:solidFill>
                  <a:srgbClr val="FFFFFF"/>
                </a:solidFill>
                <a:effectLst/>
                <a:latin typeface="Courier New" pitchFamily="49" charset="0"/>
                <a:ea typeface="Calibri"/>
                <a:cs typeface="Courier New" pitchFamily="49" charset="0"/>
              </a:rPr>
              <a:t>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NY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F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G----------Q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VPGNG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TSMAA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sp_ZP04604370		162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P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NY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I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FS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G----------Q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KPDI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PG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R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IPGGG--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GTSM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onsensus		169 ....*.... ....*.     ..... ....*..*..          . ...**.. .**. ..*.  . .  . . .......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 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 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pSsp1		234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V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ADL--------------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astaci_AAK39096		21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I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KGA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EVYTALANNVDTD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laibachii_1_CCA16972	229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V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LTSAQLFELLRTSVTTDDLKRSGYDCGAISESQYPNNAV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.laibachii_2_CCA21883	220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S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I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FANA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--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.giganteum_ABY90127	155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AK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-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1_XP002897506	220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VAGAI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T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-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2_XP002909265	220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VAG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Q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L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-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3_XP002901381	223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FC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-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infestans_4_XP002901382	    -------------------------------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1_EGZ19243	220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VAGAI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N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TS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------------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2_EGZ08708	22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FC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MKSVLTSSTD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3_EGZ12954	221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I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R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GFC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F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DTMKAVLTSSTD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P.sojae_4_EGZ15546	224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V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L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ELT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YE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KVWTALATTAT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aurantiaca_YP003835151	229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AI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LV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ITATRALLNDTA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lupini_ZP21031234	229</a:t>
            </a:r>
            <a:r>
              <a:rPr lang="en-GB" sz="650" dirty="0" smtClean="0">
                <a:solidFill>
                  <a:srgbClr val="FFFFFF"/>
                </a:solidFill>
                <a:effectLst/>
                <a:latin typeface="Courier New" pitchFamily="49" charset="0"/>
                <a:ea typeface="Calibri"/>
                <a:cs typeface="Courier New" pitchFamily="49" charset="0"/>
              </a:rPr>
              <a:t>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GAI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Y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TLI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DGTRALLNGTA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M.sp_ZP04604370		229 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H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L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GA</a:t>
            </a:r>
            <a:r>
              <a:rPr lang="en-GB" sz="650" dirty="0" smtClean="0">
                <a:effectLst/>
                <a:highlight>
                  <a:srgbClr val="D3D3D3"/>
                </a:highlight>
                <a:latin typeface="Courier New" pitchFamily="49" charset="0"/>
                <a:ea typeface="Calibri"/>
                <a:cs typeface="Courier New" pitchFamily="49" charset="0"/>
              </a:rPr>
              <a:t>V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AL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LW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SA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P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ALVG</a:t>
            </a:r>
            <a:r>
              <a:rPr lang="en-GB" sz="650" dirty="0" smtClean="0">
                <a:solidFill>
                  <a:srgbClr val="FFFFFF"/>
                </a:solidFill>
                <a:effectLst/>
                <a:highlight>
                  <a:srgbClr val="000000"/>
                </a:highlight>
                <a:latin typeface="Courier New" pitchFamily="49" charset="0"/>
                <a:ea typeface="Calibri"/>
                <a:cs typeface="Courier New" pitchFamily="49" charset="0"/>
              </a:rPr>
              <a:t>D</a:t>
            </a: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VAATR------------------------------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650" dirty="0" smtClean="0">
                <a:effectLst/>
                <a:latin typeface="Courier New" pitchFamily="49" charset="0"/>
                <a:ea typeface="Calibri"/>
                <a:cs typeface="Courier New" pitchFamily="49" charset="0"/>
              </a:rPr>
              <a:t>Consensus		253 ......... ... .   ..</a:t>
            </a:r>
            <a:endParaRPr lang="en-GB" sz="650" dirty="0">
              <a:latin typeface="Courier New" pitchFamily="49" charset="0"/>
              <a:ea typeface="Calibri"/>
              <a:cs typeface="Courier New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98337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</Words>
  <Application>Microsoft Macintosh PowerPoint</Application>
  <PresentationFormat>Custom</PresentationFormat>
  <Paragraphs>7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Aberde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s, Katie Sarah</dc:creator>
  <cp:lastModifiedBy>Van west, Dr Pieter</cp:lastModifiedBy>
  <cp:revision>2</cp:revision>
  <dcterms:created xsi:type="dcterms:W3CDTF">2013-06-20T14:16:02Z</dcterms:created>
  <dcterms:modified xsi:type="dcterms:W3CDTF">2013-07-03T12:47:49Z</dcterms:modified>
</cp:coreProperties>
</file>